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0" r:id="rId2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511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157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780B3-AAEC-45E6-B93B-3A4A3CDF57AC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0C59E-855D-4112-B066-BF90C1F092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65243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780B3-AAEC-45E6-B93B-3A4A3CDF57AC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0C59E-855D-4112-B066-BF90C1F092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0812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780B3-AAEC-45E6-B93B-3A4A3CDF57AC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0C59E-855D-4112-B066-BF90C1F092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03067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780B3-AAEC-45E6-B93B-3A4A3CDF57AC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0C59E-855D-4112-B066-BF90C1F092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84205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780B3-AAEC-45E6-B93B-3A4A3CDF57AC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0C59E-855D-4112-B066-BF90C1F092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923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780B3-AAEC-45E6-B93B-3A4A3CDF57AC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0C59E-855D-4112-B066-BF90C1F092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73405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780B3-AAEC-45E6-B93B-3A4A3CDF57AC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0C59E-855D-4112-B066-BF90C1F092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50419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780B3-AAEC-45E6-B93B-3A4A3CDF57AC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0C59E-855D-4112-B066-BF90C1F092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3375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780B3-AAEC-45E6-B93B-3A4A3CDF57AC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0C59E-855D-4112-B066-BF90C1F092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90196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780B3-AAEC-45E6-B93B-3A4A3CDF57AC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0C59E-855D-4112-B066-BF90C1F092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57614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780B3-AAEC-45E6-B93B-3A4A3CDF57AC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0C59E-855D-4112-B066-BF90C1F092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63311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D780B3-AAEC-45E6-B93B-3A4A3CDF57AC}" type="datetimeFigureOut">
              <a:rPr lang="en-US" smtClean="0"/>
              <a:t>4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40C59E-855D-4112-B066-BF90C1F092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40267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Picture 19">
            <a:extLst>
              <a:ext uri="{FF2B5EF4-FFF2-40B4-BE49-F238E27FC236}">
                <a16:creationId xmlns="" xmlns:a16="http://schemas.microsoft.com/office/drawing/2014/main" id="{587E73E5-F192-F046-8989-603C6BEC942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" r="-82" b="20281"/>
          <a:stretch/>
        </p:blipFill>
        <p:spPr>
          <a:xfrm>
            <a:off x="4177474" y="1053302"/>
            <a:ext cx="1515558" cy="1038196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="" xmlns:a16="http://schemas.microsoft.com/office/drawing/2014/main" id="{70A1A44D-B694-1549-B32E-8A7547AA8D0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1811" b="18230"/>
          <a:stretch/>
        </p:blipFill>
        <p:spPr>
          <a:xfrm>
            <a:off x="1421800" y="1052841"/>
            <a:ext cx="1519311" cy="1058575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="" xmlns:a16="http://schemas.microsoft.com/office/drawing/2014/main" id="{72E9CBDD-5D86-EC49-819B-148B78AD2BDD}"/>
              </a:ext>
            </a:extLst>
          </p:cNvPr>
          <p:cNvSpPr/>
          <p:nvPr/>
        </p:nvSpPr>
        <p:spPr>
          <a:xfrm>
            <a:off x="602981" y="3394384"/>
            <a:ext cx="5787041" cy="16267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8" b="1" dirty="0"/>
              <a:t>S4 Fig. </a:t>
            </a:r>
            <a:r>
              <a:rPr lang="en-US" sz="1108" b="1" dirty="0"/>
              <a:t>Survival of </a:t>
            </a:r>
            <a:r>
              <a:rPr lang="en-US" sz="1108" b="1" i="1" dirty="0"/>
              <a:t>M. </a:t>
            </a:r>
            <a:r>
              <a:rPr lang="en-US" sz="1108" b="1" i="1" dirty="0" err="1"/>
              <a:t>avium</a:t>
            </a:r>
            <a:r>
              <a:rPr lang="en-US" sz="1108" b="1" i="1" dirty="0"/>
              <a:t>-</a:t>
            </a:r>
            <a:r>
              <a:rPr lang="en-US" sz="1108" b="1" dirty="0"/>
              <a:t>infected</a:t>
            </a:r>
            <a:r>
              <a:rPr lang="en-US" sz="1108" b="1" i="1" dirty="0"/>
              <a:t> </a:t>
            </a:r>
            <a:r>
              <a:rPr lang="en-US" sz="1108" b="1" dirty="0"/>
              <a:t>and</a:t>
            </a:r>
            <a:r>
              <a:rPr lang="en-US" sz="1108" b="1" i="1" dirty="0"/>
              <a:t> </a:t>
            </a:r>
            <a:r>
              <a:rPr lang="en-US" sz="1108" b="1" dirty="0"/>
              <a:t>CFSE-labeled mouse AMs in the </a:t>
            </a:r>
            <a:r>
              <a:rPr lang="en-US" sz="1108" b="1" i="1" dirty="0"/>
              <a:t>M. </a:t>
            </a:r>
            <a:r>
              <a:rPr lang="en-US" sz="1108" b="1" i="1" dirty="0" err="1"/>
              <a:t>avium</a:t>
            </a:r>
            <a:r>
              <a:rPr lang="en-US" sz="1108" b="1" dirty="0"/>
              <a:t>-infected mouse lung post adoptive transfer. </a:t>
            </a:r>
          </a:p>
          <a:p>
            <a:pPr marL="211021" indent="-211021">
              <a:buAutoNum type="alphaUcParenR"/>
            </a:pPr>
            <a:r>
              <a:rPr lang="en-US" sz="1108" dirty="0"/>
              <a:t>Cell number of </a:t>
            </a:r>
            <a:r>
              <a:rPr lang="en-US" sz="1108" i="1" dirty="0"/>
              <a:t>M. </a:t>
            </a:r>
            <a:r>
              <a:rPr lang="en-US" sz="1108" i="1" dirty="0" err="1"/>
              <a:t>avium</a:t>
            </a:r>
            <a:r>
              <a:rPr lang="en-US" sz="1108" dirty="0"/>
              <a:t>-infected WT and </a:t>
            </a:r>
            <a:r>
              <a:rPr lang="en-US" sz="1108" i="1" dirty="0"/>
              <a:t>Mavs</a:t>
            </a:r>
            <a:r>
              <a:rPr lang="en-US" sz="1108" i="1" baseline="30000" dirty="0"/>
              <a:t>-/- </a:t>
            </a:r>
            <a:r>
              <a:rPr lang="en-US" sz="1108" dirty="0"/>
              <a:t>AMs in the lung of </a:t>
            </a:r>
            <a:r>
              <a:rPr lang="en-US" sz="1108" i="1" dirty="0"/>
              <a:t>M. </a:t>
            </a:r>
            <a:r>
              <a:rPr lang="en-US" sz="1108" i="1" dirty="0" err="1"/>
              <a:t>avium</a:t>
            </a:r>
            <a:r>
              <a:rPr lang="en-US" sz="1108" dirty="0"/>
              <a:t>-infected WT mice over time post AM injection.</a:t>
            </a:r>
          </a:p>
          <a:p>
            <a:pPr marL="211021" indent="-211021">
              <a:buFontTx/>
              <a:buAutoNum type="alphaUcParenR"/>
            </a:pPr>
            <a:r>
              <a:rPr lang="en-US" sz="1108" dirty="0"/>
              <a:t>Cell number of </a:t>
            </a:r>
            <a:r>
              <a:rPr lang="en-US" sz="1108" i="1" dirty="0"/>
              <a:t>M. </a:t>
            </a:r>
            <a:r>
              <a:rPr lang="en-US" sz="1108" i="1" dirty="0" err="1"/>
              <a:t>avium</a:t>
            </a:r>
            <a:r>
              <a:rPr lang="en-US" sz="1108" dirty="0"/>
              <a:t>-infected WT and </a:t>
            </a:r>
            <a:r>
              <a:rPr lang="en-US" sz="1108" i="1" dirty="0"/>
              <a:t>ICAM-1</a:t>
            </a:r>
            <a:r>
              <a:rPr lang="en-US" sz="1108" i="1" baseline="30000" dirty="0"/>
              <a:t>-/- </a:t>
            </a:r>
            <a:r>
              <a:rPr lang="en-US" sz="1108" dirty="0"/>
              <a:t>AMs in the lung of </a:t>
            </a:r>
            <a:r>
              <a:rPr lang="en-US" sz="1108" i="1" dirty="0"/>
              <a:t>M. </a:t>
            </a:r>
            <a:r>
              <a:rPr lang="en-US" sz="1108" i="1" dirty="0" err="1"/>
              <a:t>avium</a:t>
            </a:r>
            <a:r>
              <a:rPr lang="en-US" sz="1108" dirty="0"/>
              <a:t>-infected WT mice over time post AM injection.</a:t>
            </a:r>
          </a:p>
          <a:p>
            <a:pPr marL="211021" indent="-211021">
              <a:buFontTx/>
              <a:buAutoNum type="alphaUcParenR"/>
            </a:pPr>
            <a:endParaRPr lang="en-US" sz="1108" dirty="0"/>
          </a:p>
          <a:p>
            <a:r>
              <a:rPr lang="en-US" sz="1108" dirty="0"/>
              <a:t>The data shown is the combination of two independent experiments. n=3 mice per group each experiment.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="" xmlns:a16="http://schemas.microsoft.com/office/drawing/2014/main" id="{3C46C42C-A6DC-C74D-9C4F-CB6879186C9B}"/>
              </a:ext>
            </a:extLst>
          </p:cNvPr>
          <p:cNvSpPr txBox="1"/>
          <p:nvPr/>
        </p:nvSpPr>
        <p:spPr>
          <a:xfrm rot="16200000">
            <a:off x="689748" y="1494420"/>
            <a:ext cx="1317990" cy="2058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38" dirty="0"/>
              <a:t>CFSE Positive Cells (10</a:t>
            </a:r>
            <a:r>
              <a:rPr lang="en-US" sz="738" baseline="30000" dirty="0"/>
              <a:t>5</a:t>
            </a:r>
            <a:r>
              <a:rPr lang="en-US" sz="738" dirty="0"/>
              <a:t>)/Lung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="" xmlns:a16="http://schemas.microsoft.com/office/drawing/2014/main" id="{54FE0145-E783-2943-9C32-F6CA08CB05D4}"/>
              </a:ext>
            </a:extLst>
          </p:cNvPr>
          <p:cNvSpPr txBox="1"/>
          <p:nvPr/>
        </p:nvSpPr>
        <p:spPr>
          <a:xfrm rot="16200000">
            <a:off x="3424155" y="1528858"/>
            <a:ext cx="1317990" cy="2058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38" dirty="0"/>
              <a:t>CFSE Positive Cells (10</a:t>
            </a:r>
            <a:r>
              <a:rPr lang="en-US" sz="738" baseline="30000" dirty="0"/>
              <a:t>5</a:t>
            </a:r>
            <a:r>
              <a:rPr lang="en-US" sz="738" dirty="0"/>
              <a:t>)/Lung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="" xmlns:a16="http://schemas.microsoft.com/office/drawing/2014/main" id="{46D93263-5B6D-5843-B0A7-26C662DE0FFB}"/>
              </a:ext>
            </a:extLst>
          </p:cNvPr>
          <p:cNvSpPr txBox="1"/>
          <p:nvPr/>
        </p:nvSpPr>
        <p:spPr>
          <a:xfrm>
            <a:off x="945278" y="729521"/>
            <a:ext cx="293670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77" dirty="0"/>
              <a:t>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="" xmlns:a16="http://schemas.microsoft.com/office/drawing/2014/main" id="{E4911794-FCAD-AE44-BF3A-ED7819940699}"/>
              </a:ext>
            </a:extLst>
          </p:cNvPr>
          <p:cNvSpPr txBox="1"/>
          <p:nvPr/>
        </p:nvSpPr>
        <p:spPr>
          <a:xfrm>
            <a:off x="3679686" y="813274"/>
            <a:ext cx="287258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77" dirty="0"/>
              <a:t>B</a:t>
            </a:r>
          </a:p>
        </p:txBody>
      </p:sp>
      <p:grpSp>
        <p:nvGrpSpPr>
          <p:cNvPr id="38" name="Group 37">
            <a:extLst>
              <a:ext uri="{FF2B5EF4-FFF2-40B4-BE49-F238E27FC236}">
                <a16:creationId xmlns="" xmlns:a16="http://schemas.microsoft.com/office/drawing/2014/main" id="{DCBC15CB-613B-F448-A7E5-D8C3D53AE5F7}"/>
              </a:ext>
            </a:extLst>
          </p:cNvPr>
          <p:cNvGrpSpPr/>
          <p:nvPr/>
        </p:nvGrpSpPr>
        <p:grpSpPr>
          <a:xfrm>
            <a:off x="1397967" y="2402439"/>
            <a:ext cx="1294792" cy="319776"/>
            <a:chOff x="1474785" y="2265319"/>
            <a:chExt cx="1402691" cy="346424"/>
          </a:xfrm>
        </p:grpSpPr>
        <p:sp>
          <p:nvSpPr>
            <p:cNvPr id="22" name="TextBox 21">
              <a:extLst>
                <a:ext uri="{FF2B5EF4-FFF2-40B4-BE49-F238E27FC236}">
                  <a16:creationId xmlns="" xmlns:a16="http://schemas.microsoft.com/office/drawing/2014/main" id="{0F1179E4-81A1-5A49-A99D-D87965CEA146}"/>
                </a:ext>
              </a:extLst>
            </p:cNvPr>
            <p:cNvSpPr txBox="1"/>
            <p:nvPr/>
          </p:nvSpPr>
          <p:spPr>
            <a:xfrm>
              <a:off x="1723637" y="2404047"/>
              <a:ext cx="877324" cy="2076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46" dirty="0"/>
                <a:t>Time post-transfer</a:t>
              </a:r>
            </a:p>
          </p:txBody>
        </p:sp>
        <p:cxnSp>
          <p:nvCxnSpPr>
            <p:cNvPr id="23" name="Straight Connector 22">
              <a:extLst>
                <a:ext uri="{FF2B5EF4-FFF2-40B4-BE49-F238E27FC236}">
                  <a16:creationId xmlns="" xmlns:a16="http://schemas.microsoft.com/office/drawing/2014/main" id="{78690C50-8F5C-ED48-A732-31E6B6B26E78}"/>
                </a:ext>
              </a:extLst>
            </p:cNvPr>
            <p:cNvCxnSpPr/>
            <p:nvPr/>
          </p:nvCxnSpPr>
          <p:spPr>
            <a:xfrm>
              <a:off x="1509039" y="2285455"/>
              <a:ext cx="345467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>
              <a:extLst>
                <a:ext uri="{FF2B5EF4-FFF2-40B4-BE49-F238E27FC236}">
                  <a16:creationId xmlns="" xmlns:a16="http://schemas.microsoft.com/office/drawing/2014/main" id="{6424D787-40B7-0B45-9776-34ED57054E93}"/>
                </a:ext>
              </a:extLst>
            </p:cNvPr>
            <p:cNvCxnSpPr/>
            <p:nvPr/>
          </p:nvCxnSpPr>
          <p:spPr>
            <a:xfrm>
              <a:off x="1983016" y="2285455"/>
              <a:ext cx="345467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>
              <a:extLst>
                <a:ext uri="{FF2B5EF4-FFF2-40B4-BE49-F238E27FC236}">
                  <a16:creationId xmlns="" xmlns:a16="http://schemas.microsoft.com/office/drawing/2014/main" id="{104A204A-2B9A-DD4A-8ECA-3FDE8F4C1DA9}"/>
                </a:ext>
              </a:extLst>
            </p:cNvPr>
            <p:cNvCxnSpPr/>
            <p:nvPr/>
          </p:nvCxnSpPr>
          <p:spPr>
            <a:xfrm>
              <a:off x="2467829" y="2285455"/>
              <a:ext cx="345467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Box 25">
              <a:extLst>
                <a:ext uri="{FF2B5EF4-FFF2-40B4-BE49-F238E27FC236}">
                  <a16:creationId xmlns="" xmlns:a16="http://schemas.microsoft.com/office/drawing/2014/main" id="{5EEF96AF-19C0-1245-B4EF-5BE1D2E9373F}"/>
                </a:ext>
              </a:extLst>
            </p:cNvPr>
            <p:cNvSpPr txBox="1"/>
            <p:nvPr/>
          </p:nvSpPr>
          <p:spPr>
            <a:xfrm>
              <a:off x="1474785" y="2265319"/>
              <a:ext cx="404972" cy="2076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46" dirty="0"/>
                <a:t>1 Day</a:t>
              </a:r>
              <a:endParaRPr lang="en-US" sz="646" i="1" baseline="30000" dirty="0"/>
            </a:p>
          </p:txBody>
        </p:sp>
        <p:sp>
          <p:nvSpPr>
            <p:cNvPr id="27" name="TextBox 26">
              <a:extLst>
                <a:ext uri="{FF2B5EF4-FFF2-40B4-BE49-F238E27FC236}">
                  <a16:creationId xmlns="" xmlns:a16="http://schemas.microsoft.com/office/drawing/2014/main" id="{2A073CF4-76EE-8A40-A6CF-AB61038E06A4}"/>
                </a:ext>
              </a:extLst>
            </p:cNvPr>
            <p:cNvSpPr txBox="1"/>
            <p:nvPr/>
          </p:nvSpPr>
          <p:spPr>
            <a:xfrm>
              <a:off x="1937862" y="2265319"/>
              <a:ext cx="439704" cy="2076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46" dirty="0"/>
                <a:t>3 Days</a:t>
              </a:r>
              <a:endParaRPr lang="en-US" sz="646" i="1" baseline="30000" dirty="0"/>
            </a:p>
          </p:txBody>
        </p:sp>
        <p:sp>
          <p:nvSpPr>
            <p:cNvPr id="28" name="TextBox 27">
              <a:extLst>
                <a:ext uri="{FF2B5EF4-FFF2-40B4-BE49-F238E27FC236}">
                  <a16:creationId xmlns="" xmlns:a16="http://schemas.microsoft.com/office/drawing/2014/main" id="{C5991498-CFD1-A443-8BD3-A9076529E26E}"/>
                </a:ext>
              </a:extLst>
            </p:cNvPr>
            <p:cNvSpPr txBox="1"/>
            <p:nvPr/>
          </p:nvSpPr>
          <p:spPr>
            <a:xfrm>
              <a:off x="2437772" y="2265319"/>
              <a:ext cx="439704" cy="2076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46" dirty="0"/>
                <a:t>6 Days</a:t>
              </a:r>
              <a:endParaRPr lang="en-US" sz="646" i="1" baseline="30000" dirty="0"/>
            </a:p>
          </p:txBody>
        </p:sp>
      </p:grpSp>
      <p:grpSp>
        <p:nvGrpSpPr>
          <p:cNvPr id="54" name="Group 53">
            <a:extLst>
              <a:ext uri="{FF2B5EF4-FFF2-40B4-BE49-F238E27FC236}">
                <a16:creationId xmlns="" xmlns:a16="http://schemas.microsoft.com/office/drawing/2014/main" id="{7E32DA00-6293-8246-88B7-A783A51E5454}"/>
              </a:ext>
            </a:extLst>
          </p:cNvPr>
          <p:cNvGrpSpPr/>
          <p:nvPr/>
        </p:nvGrpSpPr>
        <p:grpSpPr>
          <a:xfrm>
            <a:off x="4129480" y="2403954"/>
            <a:ext cx="1280955" cy="319776"/>
            <a:chOff x="1487904" y="4426446"/>
            <a:chExt cx="1387701" cy="346424"/>
          </a:xfrm>
        </p:grpSpPr>
        <p:sp>
          <p:nvSpPr>
            <p:cNvPr id="47" name="TextBox 46">
              <a:extLst>
                <a:ext uri="{FF2B5EF4-FFF2-40B4-BE49-F238E27FC236}">
                  <a16:creationId xmlns="" xmlns:a16="http://schemas.microsoft.com/office/drawing/2014/main" id="{AE26D840-8209-B54B-9477-41F607BF8FEC}"/>
                </a:ext>
              </a:extLst>
            </p:cNvPr>
            <p:cNvSpPr txBox="1"/>
            <p:nvPr/>
          </p:nvSpPr>
          <p:spPr>
            <a:xfrm>
              <a:off x="1736756" y="4565174"/>
              <a:ext cx="877324" cy="2076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46" dirty="0"/>
                <a:t>Time post-transfer</a:t>
              </a:r>
            </a:p>
          </p:txBody>
        </p:sp>
        <p:cxnSp>
          <p:nvCxnSpPr>
            <p:cNvPr id="48" name="Straight Connector 47">
              <a:extLst>
                <a:ext uri="{FF2B5EF4-FFF2-40B4-BE49-F238E27FC236}">
                  <a16:creationId xmlns="" xmlns:a16="http://schemas.microsoft.com/office/drawing/2014/main" id="{5C467115-74FF-5249-9673-EF8F73BB2BD1}"/>
                </a:ext>
              </a:extLst>
            </p:cNvPr>
            <p:cNvCxnSpPr/>
            <p:nvPr/>
          </p:nvCxnSpPr>
          <p:spPr>
            <a:xfrm>
              <a:off x="1522158" y="4446582"/>
              <a:ext cx="345467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Connector 48">
              <a:extLst>
                <a:ext uri="{FF2B5EF4-FFF2-40B4-BE49-F238E27FC236}">
                  <a16:creationId xmlns="" xmlns:a16="http://schemas.microsoft.com/office/drawing/2014/main" id="{5BA38527-2275-B241-9212-A8C748F6437B}"/>
                </a:ext>
              </a:extLst>
            </p:cNvPr>
            <p:cNvCxnSpPr/>
            <p:nvPr/>
          </p:nvCxnSpPr>
          <p:spPr>
            <a:xfrm>
              <a:off x="1996135" y="4446582"/>
              <a:ext cx="345467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Straight Connector 49">
              <a:extLst>
                <a:ext uri="{FF2B5EF4-FFF2-40B4-BE49-F238E27FC236}">
                  <a16:creationId xmlns="" xmlns:a16="http://schemas.microsoft.com/office/drawing/2014/main" id="{C37FFD7E-5483-4241-9C65-09906F2C622A}"/>
                </a:ext>
              </a:extLst>
            </p:cNvPr>
            <p:cNvCxnSpPr/>
            <p:nvPr/>
          </p:nvCxnSpPr>
          <p:spPr>
            <a:xfrm>
              <a:off x="2465958" y="4446582"/>
              <a:ext cx="345467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TextBox 50">
              <a:extLst>
                <a:ext uri="{FF2B5EF4-FFF2-40B4-BE49-F238E27FC236}">
                  <a16:creationId xmlns="" xmlns:a16="http://schemas.microsoft.com/office/drawing/2014/main" id="{4C5DA962-58FA-6645-8A60-12DAE790BBBF}"/>
                </a:ext>
              </a:extLst>
            </p:cNvPr>
            <p:cNvSpPr txBox="1"/>
            <p:nvPr/>
          </p:nvSpPr>
          <p:spPr>
            <a:xfrm>
              <a:off x="1487904" y="4426446"/>
              <a:ext cx="404972" cy="2076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46" dirty="0"/>
                <a:t>1 Day</a:t>
              </a:r>
              <a:endParaRPr lang="en-US" sz="646" i="1" baseline="30000" dirty="0"/>
            </a:p>
          </p:txBody>
        </p:sp>
        <p:sp>
          <p:nvSpPr>
            <p:cNvPr id="52" name="TextBox 51">
              <a:extLst>
                <a:ext uri="{FF2B5EF4-FFF2-40B4-BE49-F238E27FC236}">
                  <a16:creationId xmlns="" xmlns:a16="http://schemas.microsoft.com/office/drawing/2014/main" id="{6595CD61-8385-334F-8DE2-81C901ABAB64}"/>
                </a:ext>
              </a:extLst>
            </p:cNvPr>
            <p:cNvSpPr txBox="1"/>
            <p:nvPr/>
          </p:nvSpPr>
          <p:spPr>
            <a:xfrm>
              <a:off x="1950981" y="4426446"/>
              <a:ext cx="439704" cy="2076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46" dirty="0"/>
                <a:t>3 Days</a:t>
              </a:r>
              <a:endParaRPr lang="en-US" sz="646" i="1" baseline="30000" dirty="0"/>
            </a:p>
          </p:txBody>
        </p:sp>
        <p:sp>
          <p:nvSpPr>
            <p:cNvPr id="53" name="TextBox 52">
              <a:extLst>
                <a:ext uri="{FF2B5EF4-FFF2-40B4-BE49-F238E27FC236}">
                  <a16:creationId xmlns="" xmlns:a16="http://schemas.microsoft.com/office/drawing/2014/main" id="{B8377BEE-31B2-4C4D-A21F-1BDCDA12DC2A}"/>
                </a:ext>
              </a:extLst>
            </p:cNvPr>
            <p:cNvSpPr txBox="1"/>
            <p:nvPr/>
          </p:nvSpPr>
          <p:spPr>
            <a:xfrm>
              <a:off x="2435901" y="4426446"/>
              <a:ext cx="439704" cy="2076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46" dirty="0"/>
                <a:t>6 Days</a:t>
              </a:r>
              <a:endParaRPr lang="en-US" sz="646" i="1" baseline="30000" dirty="0"/>
            </a:p>
          </p:txBody>
        </p:sp>
      </p:grpSp>
      <p:grpSp>
        <p:nvGrpSpPr>
          <p:cNvPr id="62" name="Group 61">
            <a:extLst>
              <a:ext uri="{FF2B5EF4-FFF2-40B4-BE49-F238E27FC236}">
                <a16:creationId xmlns="" xmlns:a16="http://schemas.microsoft.com/office/drawing/2014/main" id="{C234489B-E0FB-6840-A72F-B485AF3E7043}"/>
              </a:ext>
            </a:extLst>
          </p:cNvPr>
          <p:cNvGrpSpPr/>
          <p:nvPr/>
        </p:nvGrpSpPr>
        <p:grpSpPr>
          <a:xfrm>
            <a:off x="4031395" y="2102546"/>
            <a:ext cx="830772" cy="233612"/>
            <a:chOff x="4998168" y="9402312"/>
            <a:chExt cx="900004" cy="253079"/>
          </a:xfrm>
        </p:grpSpPr>
        <p:sp>
          <p:nvSpPr>
            <p:cNvPr id="65" name="TextBox 64">
              <a:extLst>
                <a:ext uri="{FF2B5EF4-FFF2-40B4-BE49-F238E27FC236}">
                  <a16:creationId xmlns="" xmlns:a16="http://schemas.microsoft.com/office/drawing/2014/main" id="{615BE2E1-363E-3545-8C17-470EC14D03B0}"/>
                </a:ext>
              </a:extLst>
            </p:cNvPr>
            <p:cNvSpPr txBox="1"/>
            <p:nvPr/>
          </p:nvSpPr>
          <p:spPr>
            <a:xfrm rot="18942738">
              <a:off x="4998168" y="9443007"/>
              <a:ext cx="566475" cy="1924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554" dirty="0"/>
                <a:t>No Transfer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="" xmlns:a16="http://schemas.microsoft.com/office/drawing/2014/main" id="{ED86D864-B64A-FF43-B067-2DE252DFE6AC}"/>
                </a:ext>
              </a:extLst>
            </p:cNvPr>
            <p:cNvSpPr txBox="1"/>
            <p:nvPr/>
          </p:nvSpPr>
          <p:spPr>
            <a:xfrm rot="18942738">
              <a:off x="5253618" y="9402312"/>
              <a:ext cx="464017" cy="1924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554" dirty="0"/>
                <a:t>WT AMs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="" xmlns:a16="http://schemas.microsoft.com/office/drawing/2014/main" id="{112B3F14-128B-6F4F-A96B-096A83FA4D5B}"/>
                </a:ext>
              </a:extLst>
            </p:cNvPr>
            <p:cNvSpPr txBox="1"/>
            <p:nvPr/>
          </p:nvSpPr>
          <p:spPr>
            <a:xfrm rot="18942738">
              <a:off x="5262233" y="9462977"/>
              <a:ext cx="635939" cy="1924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554" i="1" dirty="0"/>
                <a:t>ICAM-1</a:t>
              </a:r>
              <a:r>
                <a:rPr lang="en-US" sz="554" i="1" baseline="30000" dirty="0"/>
                <a:t>-/- </a:t>
              </a:r>
              <a:r>
                <a:rPr lang="en-US" sz="554" dirty="0"/>
                <a:t>AMs</a:t>
              </a:r>
            </a:p>
          </p:txBody>
        </p:sp>
      </p:grpSp>
      <p:grpSp>
        <p:nvGrpSpPr>
          <p:cNvPr id="70" name="Group 69">
            <a:extLst>
              <a:ext uri="{FF2B5EF4-FFF2-40B4-BE49-F238E27FC236}">
                <a16:creationId xmlns="" xmlns:a16="http://schemas.microsoft.com/office/drawing/2014/main" id="{2F563B31-FC21-474E-A8E9-56967FF0F53B}"/>
              </a:ext>
            </a:extLst>
          </p:cNvPr>
          <p:cNvGrpSpPr/>
          <p:nvPr/>
        </p:nvGrpSpPr>
        <p:grpSpPr>
          <a:xfrm>
            <a:off x="1286335" y="2131804"/>
            <a:ext cx="822675" cy="215178"/>
            <a:chOff x="4998166" y="9379827"/>
            <a:chExt cx="891232" cy="233109"/>
          </a:xfrm>
        </p:grpSpPr>
        <p:sp>
          <p:nvSpPr>
            <p:cNvPr id="71" name="TextBox 70">
              <a:extLst>
                <a:ext uri="{FF2B5EF4-FFF2-40B4-BE49-F238E27FC236}">
                  <a16:creationId xmlns="" xmlns:a16="http://schemas.microsoft.com/office/drawing/2014/main" id="{C0E5E67B-6AE7-A545-8BBC-7D139C3CB176}"/>
                </a:ext>
              </a:extLst>
            </p:cNvPr>
            <p:cNvSpPr txBox="1"/>
            <p:nvPr/>
          </p:nvSpPr>
          <p:spPr>
            <a:xfrm rot="18942738">
              <a:off x="4998166" y="9420522"/>
              <a:ext cx="566475" cy="1924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554" dirty="0"/>
                <a:t>No Transfer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="" xmlns:a16="http://schemas.microsoft.com/office/drawing/2014/main" id="{950BC37D-EDE7-C34C-A501-282F3FD520B9}"/>
                </a:ext>
              </a:extLst>
            </p:cNvPr>
            <p:cNvSpPr txBox="1"/>
            <p:nvPr/>
          </p:nvSpPr>
          <p:spPr>
            <a:xfrm rot="18942738">
              <a:off x="5246123" y="9379827"/>
              <a:ext cx="464017" cy="1924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554" dirty="0"/>
                <a:t>WT AMs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="" xmlns:a16="http://schemas.microsoft.com/office/drawing/2014/main" id="{98AC6CCE-F799-B746-99E1-DC87362E4047}"/>
                </a:ext>
              </a:extLst>
            </p:cNvPr>
            <p:cNvSpPr txBox="1"/>
            <p:nvPr/>
          </p:nvSpPr>
          <p:spPr>
            <a:xfrm rot="18942738">
              <a:off x="5315977" y="9418008"/>
              <a:ext cx="573421" cy="1924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554" i="1" dirty="0"/>
                <a:t>Mavs</a:t>
              </a:r>
              <a:r>
                <a:rPr lang="en-US" sz="554" i="1" baseline="30000" dirty="0"/>
                <a:t>-/- </a:t>
              </a:r>
              <a:r>
                <a:rPr lang="en-US" sz="554" dirty="0"/>
                <a:t>AMs</a:t>
              </a:r>
            </a:p>
          </p:txBody>
        </p:sp>
      </p:grpSp>
      <p:grpSp>
        <p:nvGrpSpPr>
          <p:cNvPr id="74" name="Group 73">
            <a:extLst>
              <a:ext uri="{FF2B5EF4-FFF2-40B4-BE49-F238E27FC236}">
                <a16:creationId xmlns="" xmlns:a16="http://schemas.microsoft.com/office/drawing/2014/main" id="{DB12763D-0164-D943-865C-1F8FF9EFFD33}"/>
              </a:ext>
            </a:extLst>
          </p:cNvPr>
          <p:cNvGrpSpPr/>
          <p:nvPr/>
        </p:nvGrpSpPr>
        <p:grpSpPr>
          <a:xfrm>
            <a:off x="1733997" y="2133866"/>
            <a:ext cx="822675" cy="215178"/>
            <a:chOff x="4998166" y="9379827"/>
            <a:chExt cx="891232" cy="233109"/>
          </a:xfrm>
        </p:grpSpPr>
        <p:sp>
          <p:nvSpPr>
            <p:cNvPr id="75" name="TextBox 74">
              <a:extLst>
                <a:ext uri="{FF2B5EF4-FFF2-40B4-BE49-F238E27FC236}">
                  <a16:creationId xmlns="" xmlns:a16="http://schemas.microsoft.com/office/drawing/2014/main" id="{440E0493-A1AB-684B-905E-402B86162055}"/>
                </a:ext>
              </a:extLst>
            </p:cNvPr>
            <p:cNvSpPr txBox="1"/>
            <p:nvPr/>
          </p:nvSpPr>
          <p:spPr>
            <a:xfrm rot="18942738">
              <a:off x="4998166" y="9420522"/>
              <a:ext cx="566475" cy="1924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554" dirty="0"/>
                <a:t>No Transfer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="" xmlns:a16="http://schemas.microsoft.com/office/drawing/2014/main" id="{A603C62D-CDC5-3F4E-8E2F-FCEEF1F867ED}"/>
                </a:ext>
              </a:extLst>
            </p:cNvPr>
            <p:cNvSpPr txBox="1"/>
            <p:nvPr/>
          </p:nvSpPr>
          <p:spPr>
            <a:xfrm rot="18942738">
              <a:off x="5246123" y="9379827"/>
              <a:ext cx="464017" cy="1924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554" dirty="0"/>
                <a:t>WT AMs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="" xmlns:a16="http://schemas.microsoft.com/office/drawing/2014/main" id="{54B166C1-8B59-AB40-B8F8-61E30B29927D}"/>
                </a:ext>
              </a:extLst>
            </p:cNvPr>
            <p:cNvSpPr txBox="1"/>
            <p:nvPr/>
          </p:nvSpPr>
          <p:spPr>
            <a:xfrm rot="18942738">
              <a:off x="5315977" y="9418008"/>
              <a:ext cx="573421" cy="1924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554" i="1" dirty="0"/>
                <a:t>Mavs</a:t>
              </a:r>
              <a:r>
                <a:rPr lang="en-US" sz="554" i="1" baseline="30000" dirty="0"/>
                <a:t>-/- </a:t>
              </a:r>
              <a:r>
                <a:rPr lang="en-US" sz="554" dirty="0"/>
                <a:t>AMs</a:t>
              </a:r>
            </a:p>
          </p:txBody>
        </p:sp>
      </p:grpSp>
      <p:grpSp>
        <p:nvGrpSpPr>
          <p:cNvPr id="78" name="Group 77">
            <a:extLst>
              <a:ext uri="{FF2B5EF4-FFF2-40B4-BE49-F238E27FC236}">
                <a16:creationId xmlns="" xmlns:a16="http://schemas.microsoft.com/office/drawing/2014/main" id="{6D51FFC6-38F4-CF46-837D-37DFC3A477DC}"/>
              </a:ext>
            </a:extLst>
          </p:cNvPr>
          <p:cNvGrpSpPr/>
          <p:nvPr/>
        </p:nvGrpSpPr>
        <p:grpSpPr>
          <a:xfrm>
            <a:off x="2174811" y="2136702"/>
            <a:ext cx="820309" cy="212857"/>
            <a:chOff x="5000730" y="9379827"/>
            <a:chExt cx="888669" cy="230595"/>
          </a:xfrm>
        </p:grpSpPr>
        <p:sp>
          <p:nvSpPr>
            <p:cNvPr id="79" name="TextBox 78">
              <a:extLst>
                <a:ext uri="{FF2B5EF4-FFF2-40B4-BE49-F238E27FC236}">
                  <a16:creationId xmlns="" xmlns:a16="http://schemas.microsoft.com/office/drawing/2014/main" id="{45918CA8-5EE9-2147-9390-94053B899041}"/>
                </a:ext>
              </a:extLst>
            </p:cNvPr>
            <p:cNvSpPr txBox="1"/>
            <p:nvPr/>
          </p:nvSpPr>
          <p:spPr>
            <a:xfrm rot="18942738">
              <a:off x="5000730" y="9413315"/>
              <a:ext cx="566475" cy="1924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554" dirty="0"/>
                <a:t>No Transfer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="" xmlns:a16="http://schemas.microsoft.com/office/drawing/2014/main" id="{9C7C022D-7A1C-1B4B-B5EC-B664E1036FA7}"/>
                </a:ext>
              </a:extLst>
            </p:cNvPr>
            <p:cNvSpPr txBox="1"/>
            <p:nvPr/>
          </p:nvSpPr>
          <p:spPr>
            <a:xfrm rot="18942738">
              <a:off x="5246124" y="9379827"/>
              <a:ext cx="464017" cy="1924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554" dirty="0"/>
                <a:t>WT AMs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="" xmlns:a16="http://schemas.microsoft.com/office/drawing/2014/main" id="{FEAD3DCD-F036-6D47-B1A2-5594C2B7B827}"/>
                </a:ext>
              </a:extLst>
            </p:cNvPr>
            <p:cNvSpPr txBox="1"/>
            <p:nvPr/>
          </p:nvSpPr>
          <p:spPr>
            <a:xfrm rot="18942738">
              <a:off x="5315977" y="9418008"/>
              <a:ext cx="573422" cy="1924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554" i="1" dirty="0"/>
                <a:t>Mavs</a:t>
              </a:r>
              <a:r>
                <a:rPr lang="en-US" sz="554" i="1" baseline="30000" dirty="0"/>
                <a:t>-/- </a:t>
              </a:r>
              <a:r>
                <a:rPr lang="en-US" sz="554" dirty="0"/>
                <a:t>AMs</a:t>
              </a:r>
            </a:p>
          </p:txBody>
        </p:sp>
      </p:grpSp>
      <p:grpSp>
        <p:nvGrpSpPr>
          <p:cNvPr id="82" name="Group 81">
            <a:extLst>
              <a:ext uri="{FF2B5EF4-FFF2-40B4-BE49-F238E27FC236}">
                <a16:creationId xmlns="" xmlns:a16="http://schemas.microsoft.com/office/drawing/2014/main" id="{306251AD-18C5-E14B-A6B4-5DE2AE209DE0}"/>
              </a:ext>
            </a:extLst>
          </p:cNvPr>
          <p:cNvGrpSpPr/>
          <p:nvPr/>
        </p:nvGrpSpPr>
        <p:grpSpPr>
          <a:xfrm>
            <a:off x="4471298" y="2104679"/>
            <a:ext cx="837217" cy="233612"/>
            <a:chOff x="4991186" y="9402312"/>
            <a:chExt cx="906986" cy="253079"/>
          </a:xfrm>
        </p:grpSpPr>
        <p:sp>
          <p:nvSpPr>
            <p:cNvPr id="83" name="TextBox 82">
              <a:extLst>
                <a:ext uri="{FF2B5EF4-FFF2-40B4-BE49-F238E27FC236}">
                  <a16:creationId xmlns="" xmlns:a16="http://schemas.microsoft.com/office/drawing/2014/main" id="{DFB95464-BD3B-944F-9DC6-62987F943765}"/>
                </a:ext>
              </a:extLst>
            </p:cNvPr>
            <p:cNvSpPr txBox="1"/>
            <p:nvPr/>
          </p:nvSpPr>
          <p:spPr>
            <a:xfrm rot="18942738">
              <a:off x="4991186" y="9442331"/>
              <a:ext cx="566475" cy="1924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554" dirty="0"/>
                <a:t>No Transfer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="" xmlns:a16="http://schemas.microsoft.com/office/drawing/2014/main" id="{A7B2EB11-5A9C-7943-A4C0-17781CFB1A75}"/>
                </a:ext>
              </a:extLst>
            </p:cNvPr>
            <p:cNvSpPr txBox="1"/>
            <p:nvPr/>
          </p:nvSpPr>
          <p:spPr>
            <a:xfrm rot="18942738">
              <a:off x="5238628" y="9402312"/>
              <a:ext cx="464017" cy="1924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554" dirty="0"/>
                <a:t>WT AMs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="" xmlns:a16="http://schemas.microsoft.com/office/drawing/2014/main" id="{77EF8EFA-542D-8749-A03D-8BB2696857B6}"/>
                </a:ext>
              </a:extLst>
            </p:cNvPr>
            <p:cNvSpPr txBox="1"/>
            <p:nvPr/>
          </p:nvSpPr>
          <p:spPr>
            <a:xfrm rot="18942738">
              <a:off x="5262233" y="9462977"/>
              <a:ext cx="635939" cy="1924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554" i="1" dirty="0"/>
                <a:t>ICAM-1</a:t>
              </a:r>
              <a:r>
                <a:rPr lang="en-US" sz="554" i="1" baseline="30000" dirty="0"/>
                <a:t>-/- </a:t>
              </a:r>
              <a:r>
                <a:rPr lang="en-US" sz="554" dirty="0"/>
                <a:t>AMs</a:t>
              </a:r>
            </a:p>
          </p:txBody>
        </p:sp>
      </p:grpSp>
      <p:grpSp>
        <p:nvGrpSpPr>
          <p:cNvPr id="86" name="Group 85">
            <a:extLst>
              <a:ext uri="{FF2B5EF4-FFF2-40B4-BE49-F238E27FC236}">
                <a16:creationId xmlns="" xmlns:a16="http://schemas.microsoft.com/office/drawing/2014/main" id="{09ADBE81-5FD4-BD4E-BE51-CF7C97B14FB5}"/>
              </a:ext>
            </a:extLst>
          </p:cNvPr>
          <p:cNvGrpSpPr/>
          <p:nvPr/>
        </p:nvGrpSpPr>
        <p:grpSpPr>
          <a:xfrm>
            <a:off x="4909591" y="2107097"/>
            <a:ext cx="831337" cy="233612"/>
            <a:chOff x="4997556" y="9402312"/>
            <a:chExt cx="900616" cy="253079"/>
          </a:xfrm>
        </p:grpSpPr>
        <p:sp>
          <p:nvSpPr>
            <p:cNvPr id="87" name="TextBox 86">
              <a:extLst>
                <a:ext uri="{FF2B5EF4-FFF2-40B4-BE49-F238E27FC236}">
                  <a16:creationId xmlns="" xmlns:a16="http://schemas.microsoft.com/office/drawing/2014/main" id="{BCA9CE38-081B-AE49-A645-FC7A24E4464A}"/>
                </a:ext>
              </a:extLst>
            </p:cNvPr>
            <p:cNvSpPr txBox="1"/>
            <p:nvPr/>
          </p:nvSpPr>
          <p:spPr>
            <a:xfrm rot="18942738">
              <a:off x="4997556" y="9441288"/>
              <a:ext cx="566475" cy="1924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554" dirty="0"/>
                <a:t>No Transfer</a:t>
              </a:r>
            </a:p>
          </p:txBody>
        </p:sp>
        <p:sp>
          <p:nvSpPr>
            <p:cNvPr id="88" name="TextBox 87">
              <a:extLst>
                <a:ext uri="{FF2B5EF4-FFF2-40B4-BE49-F238E27FC236}">
                  <a16:creationId xmlns="" xmlns:a16="http://schemas.microsoft.com/office/drawing/2014/main" id="{6A1FD862-9225-414B-A569-B972E82E64B6}"/>
                </a:ext>
              </a:extLst>
            </p:cNvPr>
            <p:cNvSpPr txBox="1"/>
            <p:nvPr/>
          </p:nvSpPr>
          <p:spPr>
            <a:xfrm rot="18942738">
              <a:off x="5238628" y="9402312"/>
              <a:ext cx="464017" cy="1924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554" dirty="0"/>
                <a:t>WT AMs</a:t>
              </a:r>
            </a:p>
          </p:txBody>
        </p:sp>
        <p:sp>
          <p:nvSpPr>
            <p:cNvPr id="89" name="TextBox 88">
              <a:extLst>
                <a:ext uri="{FF2B5EF4-FFF2-40B4-BE49-F238E27FC236}">
                  <a16:creationId xmlns="" xmlns:a16="http://schemas.microsoft.com/office/drawing/2014/main" id="{1E8FF206-2A81-694E-A0A5-D410689483F0}"/>
                </a:ext>
              </a:extLst>
            </p:cNvPr>
            <p:cNvSpPr txBox="1"/>
            <p:nvPr/>
          </p:nvSpPr>
          <p:spPr>
            <a:xfrm rot="18942738">
              <a:off x="5262233" y="9462977"/>
              <a:ext cx="635939" cy="1924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554" i="1" dirty="0"/>
                <a:t>ICAM-1</a:t>
              </a:r>
              <a:r>
                <a:rPr lang="en-US" sz="554" i="1" baseline="30000" dirty="0"/>
                <a:t>-/- </a:t>
              </a:r>
              <a:r>
                <a:rPr lang="en-US" sz="554" dirty="0"/>
                <a:t>AMs</a:t>
              </a:r>
            </a:p>
          </p:txBody>
        </p:sp>
      </p:grpSp>
      <p:sp>
        <p:nvSpPr>
          <p:cNvPr id="143" name="TextBox 142">
            <a:extLst>
              <a:ext uri="{FF2B5EF4-FFF2-40B4-BE49-F238E27FC236}">
                <a16:creationId xmlns="" xmlns:a16="http://schemas.microsoft.com/office/drawing/2014/main" id="{58AA2D51-00DE-9142-9D53-1763CE8CFAE0}"/>
              </a:ext>
            </a:extLst>
          </p:cNvPr>
          <p:cNvSpPr txBox="1"/>
          <p:nvPr/>
        </p:nvSpPr>
        <p:spPr>
          <a:xfrm>
            <a:off x="5131846" y="3611800"/>
            <a:ext cx="184731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sz="1662" dirty="0"/>
          </a:p>
        </p:txBody>
      </p:sp>
    </p:spTree>
    <p:extLst>
      <p:ext uri="{BB962C8B-B14F-4D97-AF65-F5344CB8AC3E}">
        <p14:creationId xmlns:p14="http://schemas.microsoft.com/office/powerpoint/2010/main" val="15088880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167</Words>
  <Application>Microsoft Office PowerPoint</Application>
  <PresentationFormat>Letter Paper (8.5x11 in)</PresentationFormat>
  <Paragraphs>3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Notre Dam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ffrey Schorey</dc:creator>
  <cp:lastModifiedBy>Jeffrey Schorey</cp:lastModifiedBy>
  <cp:revision>4</cp:revision>
  <dcterms:created xsi:type="dcterms:W3CDTF">2020-04-29T17:59:52Z</dcterms:created>
  <dcterms:modified xsi:type="dcterms:W3CDTF">2020-04-29T18:06:57Z</dcterms:modified>
</cp:coreProperties>
</file>